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3" r:id="rId2"/>
  </p:sldIdLst>
  <p:sldSz cx="6116638" cy="3200400"/>
  <p:notesSz cx="6858000" cy="9144000"/>
  <p:defaultTextStyle>
    <a:defPPr>
      <a:defRPr lang="en-US"/>
    </a:defPPr>
    <a:lvl1pPr marL="0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4" userDrawn="1">
          <p15:clr>
            <a:srgbClr val="A4A3A4"/>
          </p15:clr>
        </p15:guide>
        <p15:guide id="2" pos="2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  <a:srgbClr val="1B4DC0"/>
    <a:srgbClr val="D447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94" autoAdjust="0"/>
    <p:restoredTop sz="95220"/>
  </p:normalViewPr>
  <p:slideViewPr>
    <p:cSldViewPr snapToGrid="0" snapToObjects="1" showGuides="1">
      <p:cViewPr varScale="1">
        <p:scale>
          <a:sx n="141" d="100"/>
          <a:sy n="141" d="100"/>
        </p:scale>
        <p:origin x="91" y="322"/>
      </p:cViewPr>
      <p:guideLst>
        <p:guide orient="horz" pos="1124"/>
        <p:guide pos="23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0B0F96-8563-CF4A-969C-34502BCA78C4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2400" y="685800"/>
            <a:ext cx="65532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C942F3-F197-D94C-96E7-3A9D04780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385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994199"/>
            <a:ext cx="5199142" cy="68601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7497" y="1813560"/>
            <a:ext cx="4281647" cy="8178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7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205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41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7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411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4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82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8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17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25923" y="185208"/>
            <a:ext cx="1032183" cy="394419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9375" y="185208"/>
            <a:ext cx="2994604" cy="394419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285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243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173" y="2056554"/>
            <a:ext cx="5199142" cy="635635"/>
          </a:xfrm>
        </p:spPr>
        <p:txBody>
          <a:bodyPr anchor="t"/>
          <a:lstStyle>
            <a:lvl1pPr algn="l">
              <a:defRPr sz="326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173" y="1356466"/>
            <a:ext cx="5199142" cy="700087"/>
          </a:xfrm>
        </p:spPr>
        <p:txBody>
          <a:bodyPr anchor="b"/>
          <a:lstStyle>
            <a:lvl1pPr marL="0" indent="0">
              <a:buNone/>
              <a:defRPr sz="1634">
                <a:solidFill>
                  <a:schemeClr val="tx1">
                    <a:tint val="75000"/>
                  </a:schemeClr>
                </a:solidFill>
              </a:defRPr>
            </a:lvl1pPr>
            <a:lvl2pPr marL="373532" indent="0">
              <a:buNone/>
              <a:defRPr sz="1471">
                <a:solidFill>
                  <a:schemeClr val="tx1">
                    <a:tint val="75000"/>
                  </a:schemeClr>
                </a:solidFill>
              </a:defRPr>
            </a:lvl2pPr>
            <a:lvl3pPr marL="747065" indent="0">
              <a:buNone/>
              <a:defRPr sz="1307">
                <a:solidFill>
                  <a:schemeClr val="tx1">
                    <a:tint val="75000"/>
                  </a:schemeClr>
                </a:solidFill>
              </a:defRPr>
            </a:lvl3pPr>
            <a:lvl4pPr marL="112059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4pPr>
            <a:lvl5pPr marL="1494130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5pPr>
            <a:lvl6pPr marL="1867662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6pPr>
            <a:lvl7pPr marL="2241194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7pPr>
            <a:lvl8pPr marL="261472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8pPr>
            <a:lvl9pPr marL="2988259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553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9376" y="1078654"/>
            <a:ext cx="2013393" cy="3050752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44713" y="1078654"/>
            <a:ext cx="2013393" cy="3050752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771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128164"/>
            <a:ext cx="5504974" cy="533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3" y="716386"/>
            <a:ext cx="2702577" cy="298556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3" y="1014941"/>
            <a:ext cx="2702577" cy="1843935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7169" y="716386"/>
            <a:ext cx="2703639" cy="298556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7169" y="1014941"/>
            <a:ext cx="2703639" cy="1843935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512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90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93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127423"/>
            <a:ext cx="2012332" cy="542290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1437" y="127424"/>
            <a:ext cx="3419371" cy="2731453"/>
          </a:xfrm>
        </p:spPr>
        <p:txBody>
          <a:bodyPr/>
          <a:lstStyle>
            <a:lvl1pPr>
              <a:defRPr sz="2614"/>
            </a:lvl1pPr>
            <a:lvl2pPr>
              <a:defRPr sz="2288"/>
            </a:lvl2pPr>
            <a:lvl3pPr>
              <a:defRPr sz="1961"/>
            </a:lvl3pPr>
            <a:lvl4pPr>
              <a:defRPr sz="1634"/>
            </a:lvl4pPr>
            <a:lvl5pPr>
              <a:defRPr sz="1634"/>
            </a:lvl5pPr>
            <a:lvl6pPr>
              <a:defRPr sz="1634"/>
            </a:lvl6pPr>
            <a:lvl7pPr>
              <a:defRPr sz="1634"/>
            </a:lvl7pPr>
            <a:lvl8pPr>
              <a:defRPr sz="1634"/>
            </a:lvl8pPr>
            <a:lvl9pPr>
              <a:defRPr sz="163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832" y="669714"/>
            <a:ext cx="2012332" cy="2189163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7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8905" y="2240280"/>
            <a:ext cx="3669983" cy="264478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8905" y="285962"/>
            <a:ext cx="3669983" cy="1920240"/>
          </a:xfrm>
        </p:spPr>
        <p:txBody>
          <a:bodyPr/>
          <a:lstStyle>
            <a:lvl1pPr marL="0" indent="0">
              <a:buNone/>
              <a:defRPr sz="2614"/>
            </a:lvl1pPr>
            <a:lvl2pPr marL="373532" indent="0">
              <a:buNone/>
              <a:defRPr sz="2288"/>
            </a:lvl2pPr>
            <a:lvl3pPr marL="747065" indent="0">
              <a:buNone/>
              <a:defRPr sz="1961"/>
            </a:lvl3pPr>
            <a:lvl4pPr marL="1120597" indent="0">
              <a:buNone/>
              <a:defRPr sz="1634"/>
            </a:lvl4pPr>
            <a:lvl5pPr marL="1494130" indent="0">
              <a:buNone/>
              <a:defRPr sz="1634"/>
            </a:lvl5pPr>
            <a:lvl6pPr marL="1867662" indent="0">
              <a:buNone/>
              <a:defRPr sz="1634"/>
            </a:lvl6pPr>
            <a:lvl7pPr marL="2241194" indent="0">
              <a:buNone/>
              <a:defRPr sz="1634"/>
            </a:lvl7pPr>
            <a:lvl8pPr marL="2614727" indent="0">
              <a:buNone/>
              <a:defRPr sz="1634"/>
            </a:lvl8pPr>
            <a:lvl9pPr marL="2988259" indent="0">
              <a:buNone/>
              <a:defRPr sz="163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8905" y="2504758"/>
            <a:ext cx="3669983" cy="375602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099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5832" y="128164"/>
            <a:ext cx="5504974" cy="533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746760"/>
            <a:ext cx="5504974" cy="21121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5832" y="2966297"/>
            <a:ext cx="1427216" cy="17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9853" y="2966297"/>
            <a:ext cx="1936935" cy="17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3590" y="2966297"/>
            <a:ext cx="1427216" cy="1703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9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3532" rtl="0" eaLnBrk="1" latinLnBrk="0" hangingPunct="1">
        <a:spcBef>
          <a:spcPct val="0"/>
        </a:spcBef>
        <a:buNone/>
        <a:defRPr sz="35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0149" indent="-280149" algn="l" defTabSz="373532" rtl="0" eaLnBrk="1" latinLnBrk="0" hangingPunct="1">
        <a:spcBef>
          <a:spcPct val="20000"/>
        </a:spcBef>
        <a:buFont typeface="Arial"/>
        <a:buChar char="•"/>
        <a:defRPr sz="2614" kern="1200">
          <a:solidFill>
            <a:schemeClr val="tx1"/>
          </a:solidFill>
          <a:latin typeface="+mn-lt"/>
          <a:ea typeface="+mn-ea"/>
          <a:cs typeface="+mn-cs"/>
        </a:defRPr>
      </a:lvl1pPr>
      <a:lvl2pPr marL="606990" indent="-233458" algn="l" defTabSz="373532" rtl="0" eaLnBrk="1" latinLnBrk="0" hangingPunct="1">
        <a:spcBef>
          <a:spcPct val="20000"/>
        </a:spcBef>
        <a:buFont typeface="Arial"/>
        <a:buChar char="–"/>
        <a:defRPr sz="2288" kern="1200">
          <a:solidFill>
            <a:schemeClr val="tx1"/>
          </a:solidFill>
          <a:latin typeface="+mn-lt"/>
          <a:ea typeface="+mn-ea"/>
          <a:cs typeface="+mn-cs"/>
        </a:defRPr>
      </a:lvl2pPr>
      <a:lvl3pPr marL="933831" indent="-186766" algn="l" defTabSz="373532" rtl="0" eaLnBrk="1" latinLnBrk="0" hangingPunct="1">
        <a:spcBef>
          <a:spcPct val="20000"/>
        </a:spcBef>
        <a:buFont typeface="Arial"/>
        <a:buChar char="•"/>
        <a:defRPr sz="1961" kern="1200">
          <a:solidFill>
            <a:schemeClr val="tx1"/>
          </a:solidFill>
          <a:latin typeface="+mn-lt"/>
          <a:ea typeface="+mn-ea"/>
          <a:cs typeface="+mn-cs"/>
        </a:defRPr>
      </a:lvl3pPr>
      <a:lvl4pPr marL="1307363" indent="-186766" algn="l" defTabSz="373532" rtl="0" eaLnBrk="1" latinLnBrk="0" hangingPunct="1">
        <a:spcBef>
          <a:spcPct val="20000"/>
        </a:spcBef>
        <a:buFont typeface="Arial"/>
        <a:buChar char="–"/>
        <a:defRPr sz="1634" kern="1200">
          <a:solidFill>
            <a:schemeClr val="tx1"/>
          </a:solidFill>
          <a:latin typeface="+mn-lt"/>
          <a:ea typeface="+mn-ea"/>
          <a:cs typeface="+mn-cs"/>
        </a:defRPr>
      </a:lvl4pPr>
      <a:lvl5pPr marL="1680896" indent="-186766" algn="l" defTabSz="373532" rtl="0" eaLnBrk="1" latinLnBrk="0" hangingPunct="1">
        <a:spcBef>
          <a:spcPct val="20000"/>
        </a:spcBef>
        <a:buFont typeface="Arial"/>
        <a:buChar char="»"/>
        <a:defRPr sz="1634" kern="1200">
          <a:solidFill>
            <a:schemeClr val="tx1"/>
          </a:solidFill>
          <a:latin typeface="+mn-lt"/>
          <a:ea typeface="+mn-ea"/>
          <a:cs typeface="+mn-cs"/>
        </a:defRPr>
      </a:lvl5pPr>
      <a:lvl6pPr marL="2054428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6pPr>
      <a:lvl7pPr marL="2427961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7pPr>
      <a:lvl8pPr marL="2801493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8pPr>
      <a:lvl9pPr marL="3175025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1pPr>
      <a:lvl2pPr marL="37353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2pPr>
      <a:lvl3pPr marL="747065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3pPr>
      <a:lvl4pPr marL="112059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4pPr>
      <a:lvl5pPr marL="149413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5pPr>
      <a:lvl6pPr marL="186766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6pPr>
      <a:lvl7pPr marL="2241194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7pPr>
      <a:lvl8pPr marL="261472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8pPr>
      <a:lvl9pPr marL="2988259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/>
          <p:cNvPicPr>
            <a:picLocks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71358" y="2128790"/>
            <a:ext cx="702230" cy="545349"/>
          </a:xfrm>
          <a:prstGeom prst="rect">
            <a:avLst/>
          </a:prstGeom>
        </p:spPr>
      </p:pic>
      <p:pic>
        <p:nvPicPr>
          <p:cNvPr id="39" name="Picture 38"/>
          <p:cNvPicPr>
            <a:picLocks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07920" y="2130637"/>
            <a:ext cx="702230" cy="560290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337996" y="144953"/>
            <a:ext cx="1576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ea typeface="Arial" charset="0"/>
                <a:cs typeface="Arial" charset="0"/>
              </a:rPr>
              <a:t>Supplementary Figure S2. </a:t>
            </a: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99896" y="629323"/>
            <a:ext cx="700379" cy="552819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16403" y="622026"/>
            <a:ext cx="702336" cy="560290"/>
          </a:xfrm>
          <a:prstGeom prst="rect">
            <a:avLst/>
          </a:prstGeom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61791" y="622356"/>
            <a:ext cx="700874" cy="560290"/>
          </a:xfrm>
          <a:prstGeom prst="rect">
            <a:avLst/>
          </a:prstGeom>
        </p:spPr>
      </p:pic>
      <p:pic>
        <p:nvPicPr>
          <p:cNvPr id="44" name="Picture 43"/>
          <p:cNvPicPr>
            <a:picLocks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103083" y="2138044"/>
            <a:ext cx="694759" cy="545349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614507" y="1170152"/>
            <a:ext cx="6479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 err="1">
                <a:cs typeface="Arial"/>
              </a:rPr>
              <a:t>FcƴRI</a:t>
            </a:r>
            <a:r>
              <a:rPr lang="en-US" sz="700" dirty="0">
                <a:cs typeface="Arial"/>
              </a:rPr>
              <a:t> (CD64)</a:t>
            </a:r>
          </a:p>
        </p:txBody>
      </p:sp>
      <p:sp>
        <p:nvSpPr>
          <p:cNvPr id="46" name="TextBox 45"/>
          <p:cNvSpPr txBox="1"/>
          <p:nvPr/>
        </p:nvSpPr>
        <p:spPr>
          <a:xfrm rot="16200000">
            <a:off x="180142" y="802474"/>
            <a:ext cx="5854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Cell counts</a:t>
            </a:r>
          </a:p>
        </p:txBody>
      </p:sp>
      <p:sp>
        <p:nvSpPr>
          <p:cNvPr id="47" name="Rectangle 46"/>
          <p:cNvSpPr/>
          <p:nvPr/>
        </p:nvSpPr>
        <p:spPr>
          <a:xfrm>
            <a:off x="629529" y="1384147"/>
            <a:ext cx="107575" cy="8367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48" name="TextBox 47"/>
          <p:cNvSpPr txBox="1"/>
          <p:nvPr/>
        </p:nvSpPr>
        <p:spPr>
          <a:xfrm>
            <a:off x="719175" y="1337974"/>
            <a:ext cx="114165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cs typeface="Arial"/>
              </a:rPr>
              <a:t>Isotype</a:t>
            </a:r>
            <a:r>
              <a:rPr lang="en-US" sz="700" dirty="0">
                <a:cs typeface="Arial"/>
              </a:rPr>
              <a:t> control antibodies</a:t>
            </a:r>
          </a:p>
        </p:txBody>
      </p:sp>
      <p:sp>
        <p:nvSpPr>
          <p:cNvPr id="49" name="Rectangle 48"/>
          <p:cNvSpPr/>
          <p:nvPr/>
        </p:nvSpPr>
        <p:spPr>
          <a:xfrm>
            <a:off x="629529" y="1494554"/>
            <a:ext cx="107575" cy="8367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50" name="TextBox 49"/>
          <p:cNvSpPr txBox="1"/>
          <p:nvPr/>
        </p:nvSpPr>
        <p:spPr>
          <a:xfrm>
            <a:off x="719175" y="1455598"/>
            <a:ext cx="93487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Anti-</a:t>
            </a:r>
            <a:r>
              <a:rPr lang="en-US" sz="700" dirty="0" err="1">
                <a:cs typeface="Arial"/>
              </a:rPr>
              <a:t>Fc</a:t>
            </a:r>
            <a:r>
              <a:rPr lang="en-US" sz="700" dirty="0" err="1">
                <a:ea typeface="Symbol" charset="2"/>
                <a:cs typeface="Symbol" charset="2"/>
              </a:rPr>
              <a:t>g</a:t>
            </a:r>
            <a:r>
              <a:rPr lang="en-US" sz="700" dirty="0" err="1">
                <a:cs typeface="Arial"/>
              </a:rPr>
              <a:t>R</a:t>
            </a:r>
            <a:r>
              <a:rPr lang="en-US" sz="700" dirty="0">
                <a:cs typeface="Arial"/>
              </a:rPr>
              <a:t> antibodies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37996" y="400957"/>
            <a:ext cx="33105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A. Fc gamma receptor (</a:t>
            </a:r>
            <a:r>
              <a:rPr lang="en-US" sz="900" b="1" dirty="0" err="1">
                <a:cs typeface="Arial"/>
              </a:rPr>
              <a:t>FcƴR</a:t>
            </a:r>
            <a:r>
              <a:rPr lang="en-US" sz="900" b="1" dirty="0">
                <a:cs typeface="Arial"/>
              </a:rPr>
              <a:t>) expression on human macrophages 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37996" y="1905312"/>
            <a:ext cx="332014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B. Complement receptor (CR) expression on human macrophages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363186" y="1170151"/>
            <a:ext cx="67037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 err="1">
                <a:cs typeface="Arial"/>
              </a:rPr>
              <a:t>FcƴRII</a:t>
            </a:r>
            <a:r>
              <a:rPr lang="en-US" sz="700" dirty="0">
                <a:cs typeface="Arial"/>
              </a:rPr>
              <a:t> (CD32)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144719" y="1162171"/>
            <a:ext cx="6928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 err="1">
                <a:cs typeface="Arial"/>
              </a:rPr>
              <a:t>FcƴRIII</a:t>
            </a:r>
            <a:r>
              <a:rPr lang="en-US" sz="700" dirty="0">
                <a:cs typeface="Arial"/>
              </a:rPr>
              <a:t> (CD16)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41761" y="2677098"/>
            <a:ext cx="5934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cs typeface="Arial"/>
              </a:rPr>
              <a:t>CR1 (CD35)</a:t>
            </a:r>
          </a:p>
        </p:txBody>
      </p:sp>
      <p:sp>
        <p:nvSpPr>
          <p:cNvPr id="56" name="TextBox 55"/>
          <p:cNvSpPr txBox="1"/>
          <p:nvPr/>
        </p:nvSpPr>
        <p:spPr>
          <a:xfrm rot="16200000">
            <a:off x="180142" y="2309421"/>
            <a:ext cx="5854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Cell counts</a:t>
            </a:r>
          </a:p>
        </p:txBody>
      </p:sp>
      <p:sp>
        <p:nvSpPr>
          <p:cNvPr id="57" name="Rectangle 56"/>
          <p:cNvSpPr/>
          <p:nvPr/>
        </p:nvSpPr>
        <p:spPr>
          <a:xfrm>
            <a:off x="629529" y="2891094"/>
            <a:ext cx="107575" cy="8367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58" name="TextBox 57"/>
          <p:cNvSpPr txBox="1"/>
          <p:nvPr/>
        </p:nvSpPr>
        <p:spPr>
          <a:xfrm>
            <a:off x="719175" y="2844921"/>
            <a:ext cx="114165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cs typeface="Arial"/>
              </a:rPr>
              <a:t>Isotype</a:t>
            </a:r>
            <a:r>
              <a:rPr lang="en-US" sz="700" dirty="0">
                <a:cs typeface="Arial"/>
              </a:rPr>
              <a:t> control antibodies</a:t>
            </a:r>
          </a:p>
        </p:txBody>
      </p:sp>
      <p:sp>
        <p:nvSpPr>
          <p:cNvPr id="59" name="Rectangle 58"/>
          <p:cNvSpPr/>
          <p:nvPr/>
        </p:nvSpPr>
        <p:spPr>
          <a:xfrm>
            <a:off x="629529" y="3001501"/>
            <a:ext cx="107575" cy="83670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60" name="TextBox 59"/>
          <p:cNvSpPr txBox="1"/>
          <p:nvPr/>
        </p:nvSpPr>
        <p:spPr>
          <a:xfrm>
            <a:off x="719175" y="2958936"/>
            <a:ext cx="86113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Anti-CR antibodies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1378414" y="2677098"/>
            <a:ext cx="6399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cs typeface="Arial"/>
              </a:rPr>
              <a:t>CR3 (CD11b)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160072" y="2669118"/>
            <a:ext cx="63671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cs typeface="Arial"/>
              </a:rPr>
              <a:t>C5aR (CD88)</a:t>
            </a:r>
          </a:p>
        </p:txBody>
      </p:sp>
    </p:spTree>
    <p:extLst>
      <p:ext uri="{BB962C8B-B14F-4D97-AF65-F5344CB8AC3E}">
        <p14:creationId xmlns:p14="http://schemas.microsoft.com/office/powerpoint/2010/main" val="3107071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44</TotalTime>
  <Words>65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cha Kristian</dc:creator>
  <cp:lastModifiedBy>Arik Zur</cp:lastModifiedBy>
  <cp:revision>481</cp:revision>
  <cp:lastPrinted>2017-01-31T00:30:05Z</cp:lastPrinted>
  <dcterms:created xsi:type="dcterms:W3CDTF">2015-08-31T16:55:31Z</dcterms:created>
  <dcterms:modified xsi:type="dcterms:W3CDTF">2019-12-12T17:31:19Z</dcterms:modified>
</cp:coreProperties>
</file>